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3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76" userDrawn="1">
          <p15:clr>
            <a:srgbClr val="A4A3A4"/>
          </p15:clr>
        </p15:guide>
        <p15:guide id="2" pos="14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67" autoAdjust="0"/>
    <p:restoredTop sz="94590"/>
  </p:normalViewPr>
  <p:slideViewPr>
    <p:cSldViewPr snapToGrid="0" snapToObjects="1">
      <p:cViewPr varScale="1">
        <p:scale>
          <a:sx n="59" d="100"/>
          <a:sy n="59" d="100"/>
        </p:scale>
        <p:origin x="2611" y="58"/>
      </p:cViewPr>
      <p:guideLst>
        <p:guide orient="horz" pos="576"/>
        <p:guide pos="14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6F2C6B-841C-4E54-84DF-10BA70DE46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C440DA-989F-424F-AC98-F8222F90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726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010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39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66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894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312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531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832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775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080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053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046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437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13F9626-5252-134B-89E4-411614273474}"/>
              </a:ext>
            </a:extLst>
          </p:cNvPr>
          <p:cNvSpPr txBox="1"/>
          <p:nvPr/>
        </p:nvSpPr>
        <p:spPr>
          <a:xfrm>
            <a:off x="1563212" y="2274037"/>
            <a:ext cx="7247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y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F78DDCD-930F-E14D-BFCC-4BBAD9A80353}"/>
              </a:ext>
            </a:extLst>
          </p:cNvPr>
          <p:cNvSpPr txBox="1"/>
          <p:nvPr/>
        </p:nvSpPr>
        <p:spPr>
          <a:xfrm>
            <a:off x="2403403" y="2288182"/>
            <a:ext cx="7247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y 3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7BE5EC5-B848-594B-972E-695667DA9D74}"/>
              </a:ext>
            </a:extLst>
          </p:cNvPr>
          <p:cNvSpPr txBox="1"/>
          <p:nvPr/>
        </p:nvSpPr>
        <p:spPr>
          <a:xfrm>
            <a:off x="963783" y="2112516"/>
            <a:ext cx="407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E0A58BB-BC0F-1F46-85EE-18D785EE93E0}"/>
              </a:ext>
            </a:extLst>
          </p:cNvPr>
          <p:cNvSpPr txBox="1"/>
          <p:nvPr/>
        </p:nvSpPr>
        <p:spPr>
          <a:xfrm>
            <a:off x="958893" y="1600776"/>
            <a:ext cx="407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09EE640-6EB4-8340-BAB8-AC7F8391AB65}"/>
              </a:ext>
            </a:extLst>
          </p:cNvPr>
          <p:cNvSpPr txBox="1"/>
          <p:nvPr/>
        </p:nvSpPr>
        <p:spPr>
          <a:xfrm>
            <a:off x="958893" y="1082611"/>
            <a:ext cx="407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AF139D1-0AB5-1042-BC35-D1430D89086C}"/>
              </a:ext>
            </a:extLst>
          </p:cNvPr>
          <p:cNvSpPr txBox="1"/>
          <p:nvPr/>
        </p:nvSpPr>
        <p:spPr>
          <a:xfrm rot="16200000">
            <a:off x="57650" y="1405418"/>
            <a:ext cx="16177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ody Weight (g)</a:t>
            </a:r>
          </a:p>
        </p:txBody>
      </p:sp>
      <p:sp>
        <p:nvSpPr>
          <p:cNvPr id="12" name="TextBox 6">
            <a:extLst>
              <a:ext uri="{FF2B5EF4-FFF2-40B4-BE49-F238E27FC236}">
                <a16:creationId xmlns:a16="http://schemas.microsoft.com/office/drawing/2014/main" id="{D1115823-C0EC-F941-BEA6-4FCE840AED66}"/>
              </a:ext>
            </a:extLst>
          </p:cNvPr>
          <p:cNvSpPr txBox="1"/>
          <p:nvPr/>
        </p:nvSpPr>
        <p:spPr>
          <a:xfrm>
            <a:off x="1704535" y="585500"/>
            <a:ext cx="14847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HY Xenograft</a:t>
            </a:r>
          </a:p>
        </p:txBody>
      </p:sp>
      <p:sp>
        <p:nvSpPr>
          <p:cNvPr id="14" name="TextBox 6">
            <a:extLst>
              <a:ext uri="{FF2B5EF4-FFF2-40B4-BE49-F238E27FC236}">
                <a16:creationId xmlns:a16="http://schemas.microsoft.com/office/drawing/2014/main" id="{49A8F328-46B0-3D4B-B43D-31A460E35A63}"/>
              </a:ext>
            </a:extLst>
          </p:cNvPr>
          <p:cNvSpPr txBox="1"/>
          <p:nvPr/>
        </p:nvSpPr>
        <p:spPr>
          <a:xfrm>
            <a:off x="4516097" y="585500"/>
            <a:ext cx="14847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SC-4 Xenograf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DC982D7-F14F-E547-B90F-5E2F0FD817B5}"/>
              </a:ext>
            </a:extLst>
          </p:cNvPr>
          <p:cNvSpPr txBox="1"/>
          <p:nvPr/>
        </p:nvSpPr>
        <p:spPr>
          <a:xfrm>
            <a:off x="4485106" y="2270805"/>
            <a:ext cx="7247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y 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BEBF9E1-0EB8-014B-8C1F-9000C1B1890A}"/>
              </a:ext>
            </a:extLst>
          </p:cNvPr>
          <p:cNvSpPr txBox="1"/>
          <p:nvPr/>
        </p:nvSpPr>
        <p:spPr>
          <a:xfrm>
            <a:off x="5262990" y="2270805"/>
            <a:ext cx="7247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y 29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E1CDF0D-BB53-E04C-B85D-0F833CAA60BB}"/>
              </a:ext>
            </a:extLst>
          </p:cNvPr>
          <p:cNvSpPr txBox="1"/>
          <p:nvPr/>
        </p:nvSpPr>
        <p:spPr>
          <a:xfrm>
            <a:off x="3938727" y="2137776"/>
            <a:ext cx="407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218F55B-082A-3C48-9307-0A04696CAC41}"/>
              </a:ext>
            </a:extLst>
          </p:cNvPr>
          <p:cNvSpPr txBox="1"/>
          <p:nvPr/>
        </p:nvSpPr>
        <p:spPr>
          <a:xfrm>
            <a:off x="3945412" y="1681984"/>
            <a:ext cx="407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22C981A-FA2A-AD4D-9203-663353424E17}"/>
              </a:ext>
            </a:extLst>
          </p:cNvPr>
          <p:cNvSpPr txBox="1"/>
          <p:nvPr/>
        </p:nvSpPr>
        <p:spPr>
          <a:xfrm>
            <a:off x="3945412" y="1225109"/>
            <a:ext cx="4078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9B61863-FBE9-4F40-935F-210E4F3D11D3}"/>
              </a:ext>
            </a:extLst>
          </p:cNvPr>
          <p:cNvSpPr txBox="1"/>
          <p:nvPr/>
        </p:nvSpPr>
        <p:spPr>
          <a:xfrm rot="16200000">
            <a:off x="3071532" y="1402186"/>
            <a:ext cx="16177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ody Weight (g)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9F3F6F2D-E1C4-624A-BCD6-9004427128F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761" t="19945" r="37445" b="25405"/>
          <a:stretch/>
        </p:blipFill>
        <p:spPr>
          <a:xfrm>
            <a:off x="1235892" y="1065631"/>
            <a:ext cx="1790389" cy="127176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0F090091-FAF0-AC43-B834-5519B6E0B02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631" t="14078" r="36965" b="25444"/>
          <a:stretch/>
        </p:blipFill>
        <p:spPr>
          <a:xfrm>
            <a:off x="4215726" y="1031118"/>
            <a:ext cx="1678491" cy="1304077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DE0A62EB-9378-6948-8247-15CFF07378E6}"/>
              </a:ext>
            </a:extLst>
          </p:cNvPr>
          <p:cNvSpPr txBox="1"/>
          <p:nvPr/>
        </p:nvSpPr>
        <p:spPr>
          <a:xfrm>
            <a:off x="1948374" y="850491"/>
            <a:ext cx="9239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noProof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= NS</a:t>
            </a:r>
            <a:endParaRPr kumimoji="0" lang="en-US" sz="10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142D5C12-8346-284F-AE75-14AC7CC5DF69}"/>
              </a:ext>
            </a:extLst>
          </p:cNvPr>
          <p:cNvCxnSpPr/>
          <p:nvPr/>
        </p:nvCxnSpPr>
        <p:spPr>
          <a:xfrm>
            <a:off x="1795081" y="1036784"/>
            <a:ext cx="878609" cy="76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F1942602-F1FB-D74A-AE06-590691695FC3}"/>
              </a:ext>
            </a:extLst>
          </p:cNvPr>
          <p:cNvCxnSpPr/>
          <p:nvPr/>
        </p:nvCxnSpPr>
        <p:spPr>
          <a:xfrm flipV="1">
            <a:off x="1805171" y="1041590"/>
            <a:ext cx="0" cy="1242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723C919F-6826-2C4B-BC6C-9D0E3A804381}"/>
              </a:ext>
            </a:extLst>
          </p:cNvPr>
          <p:cNvCxnSpPr/>
          <p:nvPr/>
        </p:nvCxnSpPr>
        <p:spPr>
          <a:xfrm flipV="1">
            <a:off x="2668666" y="1036784"/>
            <a:ext cx="0" cy="1177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D1B169F3-282A-9E49-BA61-30C2308826C0}"/>
              </a:ext>
            </a:extLst>
          </p:cNvPr>
          <p:cNvSpPr txBox="1"/>
          <p:nvPr/>
        </p:nvSpPr>
        <p:spPr>
          <a:xfrm>
            <a:off x="4849498" y="784897"/>
            <a:ext cx="9239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noProof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= NS</a:t>
            </a:r>
            <a:endParaRPr kumimoji="0" lang="en-US" sz="10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57B8B281-C558-A847-8AD8-E31310748D34}"/>
              </a:ext>
            </a:extLst>
          </p:cNvPr>
          <p:cNvCxnSpPr/>
          <p:nvPr/>
        </p:nvCxnSpPr>
        <p:spPr>
          <a:xfrm>
            <a:off x="4696205" y="971190"/>
            <a:ext cx="878609" cy="76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AE22437C-18DF-3546-A637-0181174EED11}"/>
              </a:ext>
            </a:extLst>
          </p:cNvPr>
          <p:cNvCxnSpPr/>
          <p:nvPr/>
        </p:nvCxnSpPr>
        <p:spPr>
          <a:xfrm flipV="1">
            <a:off x="4706295" y="975996"/>
            <a:ext cx="0" cy="1242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977F3BE1-9798-904B-8A32-1392F799C125}"/>
              </a:ext>
            </a:extLst>
          </p:cNvPr>
          <p:cNvCxnSpPr/>
          <p:nvPr/>
        </p:nvCxnSpPr>
        <p:spPr>
          <a:xfrm flipV="1">
            <a:off x="5569790" y="971190"/>
            <a:ext cx="0" cy="1177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BB513A0B-1C5E-2FE9-85CC-E4B0BDD1BDD5}"/>
              </a:ext>
            </a:extLst>
          </p:cNvPr>
          <p:cNvSpPr txBox="1"/>
          <p:nvPr/>
        </p:nvSpPr>
        <p:spPr>
          <a:xfrm>
            <a:off x="144469" y="2896234"/>
            <a:ext cx="6400800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6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ight profiles of xenograft models treated with SHP099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eights of mice used in the BHY (left) and HSC-4 (right) xenograft models were monitored. Mouse weights are graphed for day 1 and day 30 for the BHY model and day 1 and day 29 for the HSC-4 model. Data are presented as means ± S.E.M. Statistical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ignificance was determined using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lcoxon- matched -pairs signed rank test, p value= not significant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36564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35</TotalTime>
  <Words>122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VC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Faber</dc:creator>
  <cp:lastModifiedBy>richard</cp:lastModifiedBy>
  <cp:revision>348</cp:revision>
  <cp:lastPrinted>2019-09-23T20:12:05Z</cp:lastPrinted>
  <dcterms:created xsi:type="dcterms:W3CDTF">2019-03-07T03:13:48Z</dcterms:created>
  <dcterms:modified xsi:type="dcterms:W3CDTF">2022-07-07T10:44:37Z</dcterms:modified>
</cp:coreProperties>
</file>